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13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448" y="62"/>
      </p:cViewPr>
      <p:guideLst>
        <p:guide orient="horz" pos="2880"/>
        <p:guide pos="13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763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935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436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864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637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140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92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285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427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256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971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0FB-A2BF-4C80-BB46-64D1BF455C7C}" type="datetimeFigureOut">
              <a:rPr lang="en-US" smtClean="0"/>
              <a:t>2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FA0B8-4953-4A7A-94FD-D14E83101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165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D0CB861A-6CD9-3965-4347-87467F67A318}"/>
              </a:ext>
            </a:extLst>
          </p:cNvPr>
          <p:cNvGrpSpPr/>
          <p:nvPr/>
        </p:nvGrpSpPr>
        <p:grpSpPr>
          <a:xfrm>
            <a:off x="1461472" y="190759"/>
            <a:ext cx="271907" cy="5726785"/>
            <a:chOff x="1461472" y="190759"/>
            <a:chExt cx="271907" cy="5726785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441D3DB-1100-30C5-F7C8-DBCC53B2AA1D}"/>
                </a:ext>
              </a:extLst>
            </p:cNvPr>
            <p:cNvSpPr txBox="1"/>
            <p:nvPr/>
          </p:nvSpPr>
          <p:spPr>
            <a:xfrm>
              <a:off x="1470912" y="190759"/>
              <a:ext cx="2624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0866C25-7CC2-14DC-A004-5B13AE515C97}"/>
                </a:ext>
              </a:extLst>
            </p:cNvPr>
            <p:cNvSpPr txBox="1"/>
            <p:nvPr/>
          </p:nvSpPr>
          <p:spPr>
            <a:xfrm>
              <a:off x="1461472" y="2778511"/>
              <a:ext cx="2624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8E8D162-531D-FA6D-E549-26215548CA87}"/>
                </a:ext>
              </a:extLst>
            </p:cNvPr>
            <p:cNvSpPr txBox="1"/>
            <p:nvPr/>
          </p:nvSpPr>
          <p:spPr>
            <a:xfrm>
              <a:off x="1470912" y="5609767"/>
              <a:ext cx="2624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EC66C342-2909-23FE-DD45-C91204787BFB}"/>
              </a:ext>
            </a:extLst>
          </p:cNvPr>
          <p:cNvSpPr txBox="1"/>
          <p:nvPr/>
        </p:nvSpPr>
        <p:spPr>
          <a:xfrm>
            <a:off x="420130" y="8216485"/>
            <a:ext cx="628958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3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oading plot related with the Principal Component Analysis (PCA), shown in Figure1, performed on polyphenols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lipids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nd volatile organic compounds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 The detailed list of each compound present in the loading plot are reported in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1-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pectively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BE24063-CE23-4FF8-F9AE-8CF6F14AABE2}"/>
              </a:ext>
            </a:extLst>
          </p:cNvPr>
          <p:cNvSpPr txBox="1"/>
          <p:nvPr/>
        </p:nvSpPr>
        <p:spPr>
          <a:xfrm>
            <a:off x="76199" y="36870"/>
            <a:ext cx="1813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3</a:t>
            </a:r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51DC9D72-F383-417A-F73C-20E62F26033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106"/>
          <a:stretch/>
        </p:blipFill>
        <p:spPr>
          <a:xfrm>
            <a:off x="1680039" y="406202"/>
            <a:ext cx="3776444" cy="2587752"/>
          </a:xfrm>
          <a:prstGeom prst="rect">
            <a:avLst/>
          </a:prstGeom>
        </p:spPr>
      </p:pic>
      <p:pic>
        <p:nvPicPr>
          <p:cNvPr id="6" name="Picture 5" descr="Chart, line chart&#10;&#10;Description automatically generated">
            <a:extLst>
              <a:ext uri="{FF2B5EF4-FFF2-40B4-BE49-F238E27FC236}">
                <a16:creationId xmlns:a16="http://schemas.microsoft.com/office/drawing/2014/main" id="{E4885392-CA13-30E4-B5DE-A42E22C6046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106"/>
          <a:stretch/>
        </p:blipFill>
        <p:spPr>
          <a:xfrm>
            <a:off x="1677007" y="3021641"/>
            <a:ext cx="3776445" cy="2587752"/>
          </a:xfrm>
          <a:prstGeom prst="rect">
            <a:avLst/>
          </a:prstGeom>
        </p:spPr>
      </p:pic>
      <p:pic>
        <p:nvPicPr>
          <p:cNvPr id="16" name="Picture 15" descr="Chart, scatter chart&#10;&#10;Description automatically generated">
            <a:extLst>
              <a:ext uri="{FF2B5EF4-FFF2-40B4-BE49-F238E27FC236}">
                <a16:creationId xmlns:a16="http://schemas.microsoft.com/office/drawing/2014/main" id="{A21EC43C-F281-680F-FBF5-8F80AD77209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20" r="16346"/>
          <a:stretch/>
        </p:blipFill>
        <p:spPr>
          <a:xfrm>
            <a:off x="1830859" y="5695075"/>
            <a:ext cx="2706129" cy="2587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470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6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Fondazione Edmund Ma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opulin</dc:creator>
  <cp:lastModifiedBy>Francesca Populin</cp:lastModifiedBy>
  <cp:revision>7</cp:revision>
  <dcterms:created xsi:type="dcterms:W3CDTF">2022-08-01T12:33:31Z</dcterms:created>
  <dcterms:modified xsi:type="dcterms:W3CDTF">2023-02-21T10:13:23Z</dcterms:modified>
</cp:coreProperties>
</file>